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418" r:id="rId2"/>
    <p:sldId id="419" r:id="rId3"/>
    <p:sldId id="427" r:id="rId4"/>
    <p:sldId id="420" r:id="rId5"/>
    <p:sldId id="415" r:id="rId6"/>
    <p:sldId id="426" r:id="rId7"/>
    <p:sldId id="424" r:id="rId8"/>
    <p:sldId id="425" r:id="rId9"/>
    <p:sldId id="414" r:id="rId10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94">
          <p15:clr>
            <a:srgbClr val="A4A3A4"/>
          </p15:clr>
        </p15:guide>
        <p15:guide id="2" pos="386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39" autoAdjust="0"/>
    <p:restoredTop sz="95164" autoAdjust="0"/>
  </p:normalViewPr>
  <p:slideViewPr>
    <p:cSldViewPr snapToObjects="1">
      <p:cViewPr>
        <p:scale>
          <a:sx n="144" d="100"/>
          <a:sy n="144" d="100"/>
        </p:scale>
        <p:origin x="2920" y="-1264"/>
      </p:cViewPr>
      <p:guideLst>
        <p:guide orient="horz" pos="4694"/>
        <p:guide pos="386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F46A9E-4CAE-4094-9996-CE08656F0187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1F0147D-6185-4045-9309-C3B087D0DB8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0999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4. cTAGE5 controls LBR localization and stability. 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(A) MEF cells were immuno-stained with LBR (red) and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TAGE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green). SE, short exposure; LE,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long exposure. 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cale bar, 10 µm. Note the distribution of LBR into cytoplasm increased significantly in cTAGE5 KO cells. (B) MEF cells were stained with LBR (red) and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(green). Note the co-localization of LBR with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ip</a:t>
            </a:r>
            <a:r>
              <a:rPr lang="en-US" altLang="zh-CN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creased in cTAGE5 KO cells. Scale bar, 10 µm. (C) The protein expression LBR was also significantly reduced in KO MEF . (D) The degradation of LBR was significantly faster in KO MEF than that of control cells treated with CHX. Ruler: 10 </a:t>
            </a:r>
            <a:r>
              <a:rPr lang="en-US" altLang="zh-CN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μm</a:t>
            </a:r>
            <a:r>
              <a:rPr lang="en-US" altLang="zh-CN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</a:t>
            </a:r>
            <a:endParaRPr lang="zh-CN" altLang="zh-CN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1F0147D-6185-4045-9309-C3B087D0DB83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3726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781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3306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22072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20819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8147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0425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08116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733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88996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0356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34939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64FD1F-B4C4-4DE2-A825-26FFCC5CADFB}" type="datetimeFigureOut">
              <a:rPr lang="zh-CN" altLang="en-US" smtClean="0"/>
              <a:pPr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A3794-DC5E-4EAE-9D88-8576E4621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4111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1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C8330C06-D6E2-1EB7-958F-BFDAC0AFBA31}"/>
              </a:ext>
            </a:extLst>
          </p:cNvPr>
          <p:cNvSpPr txBox="1"/>
          <p:nvPr/>
        </p:nvSpPr>
        <p:spPr>
          <a:xfrm>
            <a:off x="528521" y="7272300"/>
            <a:ext cx="580095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1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Loss of cTAGE5 leads to cell senescence in MEF cells. A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mmunofluorescence staining of P21 and the percentage of positive cells were quantified (n=100 cells)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-C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ASP markers were stained and quantified as above. Statistical analysis: two-tailed unpaired Student’s t test. ***p &lt; 0.001; **p &lt; 0.01. Scale bars, 10 µm.</a:t>
            </a:r>
            <a:endParaRPr lang="zh-CN" altLang="zh-CN" sz="1200" kern="0" spc="1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3196" y="557636"/>
            <a:ext cx="4480560" cy="6464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72756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2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76483"/>
            <a:ext cx="6858000" cy="83910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93181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7B6B485-E9CE-B590-8010-0526D186E6D0}"/>
              </a:ext>
            </a:extLst>
          </p:cNvPr>
          <p:cNvSpPr txBox="1"/>
          <p:nvPr/>
        </p:nvSpPr>
        <p:spPr>
          <a:xfrm>
            <a:off x="388067" y="1007604"/>
            <a:ext cx="6088513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2. Aging-related loss of genomic and </a:t>
            </a:r>
            <a:r>
              <a:rPr lang="en-US" altLang="zh-CN" sz="1200" b="1" kern="0" spc="1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pigenomic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stability in the primary cultured hepatocytes. A. </a:t>
            </a:r>
            <a:r>
              <a:rPr lang="en-US" altLang="zh-CN" sz="1200" kern="0" spc="1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mmunofluorescent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staining of cTAGE5 to indicate its efficient KO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γ-H2AX staining and foci quantification (n = 100 cells)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H3K9me3 staining shown on the left; H3K9me3-positive cells are quantified as fold changes of their fluorescent intensity (n = 100 cells).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D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mmunofluorescence staining of P21 and the percentage of positive cells were quantified (n=100 cells)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-G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ASP markers were stained and quantified as above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H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Hepatocytes were cultivated in a 12-well plate to an appropriate density and stained for β-galactosidase (β-Gal) activity. (n = 6 wells; mean ± SEM). Statistical analysis: two-tailed unpaired Student’s t test. *p &lt; 0.05; **p &lt; 0.01. Scale bars, 10 µm.</a:t>
            </a:r>
            <a:endParaRPr lang="zh-CN" altLang="zh-CN" sz="1200" kern="0" spc="1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1499562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3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7B6B485-E9CE-B590-8010-0526D186E6D0}"/>
              </a:ext>
            </a:extLst>
          </p:cNvPr>
          <p:cNvSpPr txBox="1"/>
          <p:nvPr/>
        </p:nvSpPr>
        <p:spPr>
          <a:xfrm>
            <a:off x="384743" y="4102784"/>
            <a:ext cx="6088513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3. ER stress is not activated in cTAGE5 KO MEF cells. A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plicing of XBP1 mRNA upon ER stress. MEF cells were treated with 1</a:t>
            </a:r>
            <a:r>
              <a:rPr lang="zh-CN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μ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/ml </a:t>
            </a:r>
            <a:r>
              <a:rPr lang="en-US" altLang="zh-CN" sz="1200" kern="0" spc="1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tunicamycin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for the indicated time and total RNA prepared was amplified by RT-PCR. Spliced versions of XBP1 cDNA was comparable between Ctrl and KO. Ns, not significant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The protein levels of </a:t>
            </a:r>
            <a:r>
              <a:rPr lang="en-US" altLang="zh-CN" sz="1200" kern="0" spc="1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ip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and Chop, two ER stress markers, were not upregulated in KO MEF cells, indicating that ER stress was not induced. Statistical analysis: two-tailed unpaired Student’s t test. ns, not significant.</a:t>
            </a:r>
            <a:endParaRPr lang="zh-CN" altLang="zh-CN" sz="1200" kern="0" spc="1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3554" y="1079612"/>
            <a:ext cx="4736592" cy="2715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434238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4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7B6B485-E9CE-B590-8010-0526D186E6D0}"/>
              </a:ext>
            </a:extLst>
          </p:cNvPr>
          <p:cNvSpPr txBox="1"/>
          <p:nvPr/>
        </p:nvSpPr>
        <p:spPr>
          <a:xfrm>
            <a:off x="448827" y="4716016"/>
            <a:ext cx="6088513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4.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</a:t>
            </a:r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Strategy for knocking in the EGFP/</a:t>
            </a:r>
            <a:r>
              <a:rPr lang="en-US" altLang="zh-CN" sz="1200" kern="0" spc="1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mEGFP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tag into the </a:t>
            </a:r>
            <a:r>
              <a:rPr lang="en-US" altLang="zh-CN" sz="1200" i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TAGE5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genome using CRISPR/Cas9. </a:t>
            </a:r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Characterization of </a:t>
            </a:r>
            <a:r>
              <a:rPr lang="en-US" altLang="zh-CN" sz="1200" i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TAGE5-EGFP-KI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MEF cells by western blotting using antibodies against GFP (top) and cTAGE5 (bottom). </a:t>
            </a:r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. Characterization of </a:t>
            </a:r>
            <a:r>
              <a:rPr lang="en-US" altLang="zh-CN" sz="1200" i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TAGE5-mEGFP</a:t>
            </a:r>
            <a:r>
              <a:rPr lang="en-US" altLang="zh-CN" sz="1200" kern="0" spc="1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+/+</a:t>
            </a:r>
            <a:r>
              <a:rPr lang="en-US" altLang="zh-CN" sz="1200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SUM159 cells by western blotting using antibodies against GFP (top) and cTAGE5 (bottom).</a:t>
            </a:r>
            <a:endParaRPr lang="zh-CN" altLang="zh-CN" sz="1000" kern="100" dirty="0">
              <a:effectLst/>
              <a:latin typeface="Calibri" panose="020F0502020204030204" pitchFamily="34" charset="0"/>
              <a:ea typeface="宋体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88" y="668090"/>
            <a:ext cx="5399532" cy="3086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3993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5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438BBBF-271B-7704-E22C-4DC63FDB109A}"/>
              </a:ext>
            </a:extLst>
          </p:cNvPr>
          <p:cNvSpPr txBox="1"/>
          <p:nvPr/>
        </p:nvSpPr>
        <p:spPr>
          <a:xfrm>
            <a:off x="447349" y="7524328"/>
            <a:ext cx="6150003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S5. Subcellular distribution of cTAGE5. A and B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Gene-edited cTAGE5-mEGFP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UM159 cells were transfected with the indicated plasmids and then imaged by spinning-disk confocal microscopy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TAGE5-mEGFP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sz="1200" i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SUM159 cells were transfected with Rtn4a-mScarlet3 or mScarlet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Climp63 and then imaged by spinning-disk confocal microscopy. Plots showing the fluorescent intensity profile along the lines on the merged image. </a:t>
            </a:r>
            <a:r>
              <a:rPr lang="en-US" sz="1200" b="1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D. 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cTAGE5-mEGFP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+/+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SUM159 cells were transfected with Rtn4a-mScarlet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 or mScarlet</a:t>
            </a:r>
            <a:r>
              <a:rPr lang="en-US" altLang="zh-CN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-Climp63 and then imaged by spinning-disk confocal microscopy. The montage shows the distribution of cTAGE5 with Rtn4a or Climp63 during the cell cycle.  Scale bars, 10 µm.</a:t>
            </a:r>
            <a:endParaRPr lang="en-US" sz="1200" kern="100" dirty="0">
              <a:effectLst/>
              <a:latin typeface="Calibri" panose="020F0502020204030204" pitchFamily="34" charset="0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B4BD637C-728A-823E-E79C-6566C77C9D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7399" y="307779"/>
            <a:ext cx="5563202" cy="7180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723901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6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7B6B485-E9CE-B590-8010-0526D186E6D0}"/>
              </a:ext>
            </a:extLst>
          </p:cNvPr>
          <p:cNvSpPr txBox="1"/>
          <p:nvPr/>
        </p:nvSpPr>
        <p:spPr>
          <a:xfrm>
            <a:off x="403913" y="6336749"/>
            <a:ext cx="6088513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kern="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6. H&amp;E and Sirius red staining on tissue sections. A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ssessment of histological alterations for brain, heart or kidney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B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H&amp;E staining on muscle and liver tissue sections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Notably, centralized nuclei were seen in muscle fibers (arrow) and fibrotic areas in the liver tissue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(arrow)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ncreased relative to that in the control liver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Sirius red staining revealed the fibrosis bridge on liver sections (arrow).</a:t>
            </a:r>
            <a:endParaRPr lang="zh-CN" altLang="zh-CN" sz="1200" kern="0" spc="1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id="{F6351271-2BC2-F79E-449E-F1FD59E386DD}"/>
              </a:ext>
            </a:extLst>
          </p:cNvPr>
          <p:cNvGrpSpPr/>
          <p:nvPr/>
        </p:nvGrpSpPr>
        <p:grpSpPr>
          <a:xfrm>
            <a:off x="395004" y="575076"/>
            <a:ext cx="6063176" cy="5556328"/>
            <a:chOff x="305885" y="651662"/>
            <a:chExt cx="6063176" cy="555632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127E367F-3A5E-988A-4CCA-DF29D57CCE0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5885" y="651662"/>
              <a:ext cx="6063176" cy="5556328"/>
            </a:xfrm>
            <a:prstGeom prst="rect">
              <a:avLst/>
            </a:prstGeom>
          </p:spPr>
        </p:pic>
        <p:cxnSp>
          <p:nvCxnSpPr>
            <p:cNvPr id="15" name="直接连接符 12">
              <a:extLst>
                <a:ext uri="{FF2B5EF4-FFF2-40B4-BE49-F238E27FC236}">
                  <a16:creationId xmlns:a16="http://schemas.microsoft.com/office/drawing/2014/main" id="{A6EB351E-82A6-0053-D2CB-4A9B5E3183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235067" y="2810402"/>
              <a:ext cx="252028" cy="204910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连接符 12">
              <a:extLst>
                <a:ext uri="{FF2B5EF4-FFF2-40B4-BE49-F238E27FC236}">
                  <a16:creationId xmlns:a16="http://schemas.microsoft.com/office/drawing/2014/main" id="{8DA612DA-BEAE-D736-C7C6-827851387BC0}"/>
                </a:ext>
              </a:extLst>
            </p:cNvPr>
            <p:cNvCxnSpPr>
              <a:cxnSpLocks/>
            </p:cNvCxnSpPr>
            <p:nvPr/>
          </p:nvCxnSpPr>
          <p:spPr>
            <a:xfrm>
              <a:off x="2235067" y="3312434"/>
              <a:ext cx="252028" cy="216000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连接符 12">
              <a:extLst>
                <a:ext uri="{FF2B5EF4-FFF2-40B4-BE49-F238E27FC236}">
                  <a16:creationId xmlns:a16="http://schemas.microsoft.com/office/drawing/2014/main" id="{E69B96EC-0DA3-8645-1D6D-64CA9FDF047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2042102" y="3592787"/>
              <a:ext cx="432048" cy="351741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连接符 12">
              <a:extLst>
                <a:ext uri="{FF2B5EF4-FFF2-40B4-BE49-F238E27FC236}">
                  <a16:creationId xmlns:a16="http://schemas.microsoft.com/office/drawing/2014/main" id="{C9F924A3-D2DF-6FEB-8634-6632A6A38C0B}"/>
                </a:ext>
              </a:extLst>
            </p:cNvPr>
            <p:cNvCxnSpPr>
              <a:cxnSpLocks/>
            </p:cNvCxnSpPr>
            <p:nvPr/>
          </p:nvCxnSpPr>
          <p:spPr>
            <a:xfrm>
              <a:off x="2042102" y="4252687"/>
              <a:ext cx="450794" cy="67285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连接符 12">
              <a:extLst>
                <a:ext uri="{FF2B5EF4-FFF2-40B4-BE49-F238E27FC236}">
                  <a16:creationId xmlns:a16="http://schemas.microsoft.com/office/drawing/2014/main" id="{E38D9292-1BF2-CDA8-C717-762AC6DB4B4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997214" y="2810402"/>
              <a:ext cx="376002" cy="157779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连接符 12">
              <a:extLst>
                <a:ext uri="{FF2B5EF4-FFF2-40B4-BE49-F238E27FC236}">
                  <a16:creationId xmlns:a16="http://schemas.microsoft.com/office/drawing/2014/main" id="{293AFEFF-A28D-0570-C1C6-F6917867B1BF}"/>
                </a:ext>
              </a:extLst>
            </p:cNvPr>
            <p:cNvCxnSpPr>
              <a:cxnSpLocks/>
            </p:cNvCxnSpPr>
            <p:nvPr/>
          </p:nvCxnSpPr>
          <p:spPr>
            <a:xfrm>
              <a:off x="4997214" y="3266860"/>
              <a:ext cx="365760" cy="256032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接连接符 12">
              <a:extLst>
                <a:ext uri="{FF2B5EF4-FFF2-40B4-BE49-F238E27FC236}">
                  <a16:creationId xmlns:a16="http://schemas.microsoft.com/office/drawing/2014/main" id="{F55096F2-A4EE-D91E-B847-01528E80FA6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74375" y="3592787"/>
              <a:ext cx="98841" cy="367428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连接符 12">
              <a:extLst>
                <a:ext uri="{FF2B5EF4-FFF2-40B4-BE49-F238E27FC236}">
                  <a16:creationId xmlns:a16="http://schemas.microsoft.com/office/drawing/2014/main" id="{37DDE2E3-AFA8-A054-3CC7-E2F921E9A819}"/>
                </a:ext>
              </a:extLst>
            </p:cNvPr>
            <p:cNvCxnSpPr>
              <a:cxnSpLocks/>
            </p:cNvCxnSpPr>
            <p:nvPr/>
          </p:nvCxnSpPr>
          <p:spPr>
            <a:xfrm>
              <a:off x="5268478" y="4261009"/>
              <a:ext cx="104738" cy="58963"/>
            </a:xfrm>
            <a:prstGeom prst="line">
              <a:avLst/>
            </a:prstGeom>
            <a:ln w="6350">
              <a:solidFill>
                <a:schemeClr val="bg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29551689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7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7B6B485-E9CE-B590-8010-0526D186E6D0}"/>
              </a:ext>
            </a:extLst>
          </p:cNvPr>
          <p:cNvSpPr txBox="1"/>
          <p:nvPr/>
        </p:nvSpPr>
        <p:spPr>
          <a:xfrm>
            <a:off x="1" y="6912260"/>
            <a:ext cx="6858000" cy="23083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Figure S7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Loss of cTAGE5 leads to cell senescence in liver (A-D) and muscle (E-F) tissues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A. </a:t>
            </a:r>
            <a:r>
              <a:rPr lang="en-US" altLang="zh-CN" sz="1200" kern="0" spc="10" dirty="0" err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mmunofluorescent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staining of H3K9me3 shown on the left; H3K9me3-positive cells are quantified as fold changes of their fluorescent intensity (n = 100 cells).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B-D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mmunofluorescence staining of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SASP markers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and the percentage of positive cells were quantified (n=100 cells). 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E. </a:t>
            </a:r>
            <a:r>
              <a:rPr lang="en-US" altLang="zh-CN" sz="1200" kern="0" spc="10" dirty="0" err="1">
                <a:solidFill>
                  <a:srgbClr val="000000"/>
                </a:solidFill>
                <a:latin typeface="Times New Roman" panose="02020603050405020304" pitchFamily="18" charset="0"/>
              </a:rPr>
              <a:t>Immunofluorescent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 staining of H3K9me3 shown on the left; H3K9me3-positive cells are quantified as fold changes of their fluorescent intensity (n = 100 cells).</a:t>
            </a:r>
            <a:r>
              <a:rPr lang="en-US" altLang="zh-CN" sz="1200" b="1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 F-H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</a:rPr>
              <a:t>Immunofluorescence staining of SASP markers and the percentage of positive cells were quantified (n=100 cells). </a:t>
            </a:r>
            <a:r>
              <a:rPr lang="en-US" altLang="zh-CN" sz="1200" kern="0" spc="1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tatistical analysis: two-tailed unpaired Student’s t test. **p &lt; 0.01. Scale bars, 10 µm.</a:t>
            </a:r>
            <a:endParaRPr lang="zh-CN" altLang="zh-CN" sz="1200" kern="0" spc="1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9" y="314493"/>
            <a:ext cx="6858000" cy="6674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706598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"/>
          <p:cNvSpPr txBox="1"/>
          <p:nvPr/>
        </p:nvSpPr>
        <p:spPr>
          <a:xfrm>
            <a:off x="-1" y="2"/>
            <a:ext cx="101672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Arial" pitchFamily="34" charset="0"/>
                <a:cs typeface="Arial" pitchFamily="34" charset="0"/>
              </a:rPr>
              <a:t>Figure S8</a:t>
            </a:r>
            <a:endParaRPr lang="zh-CN" altLang="en-US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6FB50638-C64F-2061-D4E4-1C2E3B63EAF7}"/>
              </a:ext>
            </a:extLst>
          </p:cNvPr>
          <p:cNvSpPr txBox="1"/>
          <p:nvPr/>
        </p:nvSpPr>
        <p:spPr>
          <a:xfrm>
            <a:off x="365273" y="6825151"/>
            <a:ext cx="6127453" cy="203132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eaLnBrk="0">
              <a:lnSpc>
                <a:spcPct val="150000"/>
              </a:lnSpc>
            </a:pPr>
            <a:r>
              <a:rPr lang="en-US" altLang="zh-CN" sz="1200" b="1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Figure S8. Cell </a:t>
            </a:r>
            <a:r>
              <a:rPr lang="en-US" altLang="zh-CN" sz="1200" b="1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enescence and proliferation can be rescued by cTAGE5 overexpression in KO MEF cells.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b="1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A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. Western blot analysis was performed on lysates from Ctrl, KO and TG MEF cells (left). Protein expression levels were quantified (right; </a:t>
            </a:r>
            <a:r>
              <a:rPr lang="en-US" altLang="zh-CN" sz="120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n = 3 independent experiments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;</a:t>
            </a:r>
            <a:r>
              <a:rPr lang="en-US" altLang="zh-CN" sz="120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mean ± SEM). ns, not significant; **p &lt; 0.01 (Two tailed unpaired Student’s t test).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b="1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B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and </a:t>
            </a:r>
            <a:r>
              <a:rPr lang="en-US" altLang="zh-CN" sz="1200" b="1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C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. γ-H2AX staining and quantification. (n = 100 cells per group; </a:t>
            </a:r>
            <a:r>
              <a:rPr lang="en-US" altLang="zh-CN" sz="120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mean ± SEM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. Scale bar, 10 µm. </a:t>
            </a:r>
            <a:r>
              <a:rPr lang="en-US" altLang="zh-CN" sz="1200" b="1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D</a:t>
            </a:r>
            <a:r>
              <a:rPr lang="en-US" altLang="zh-CN" sz="1200" spc="1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. Cell growth was</a:t>
            </a:r>
            <a:r>
              <a:rPr lang="en-US" altLang="zh-CN" sz="120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assessed using the MTT assay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(</a:t>
            </a:r>
            <a:r>
              <a:rPr lang="en-US" altLang="zh-CN" sz="1200" spc="1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n = 3 independent experiments; mean ± SEM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).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2597" y="362108"/>
            <a:ext cx="5401056" cy="6550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9491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105</TotalTime>
  <Words>1008</Words>
  <Application>Microsoft Macintosh PowerPoint</Application>
  <PresentationFormat>On-screen Show (4:3)</PresentationFormat>
  <Paragraphs>19</Paragraphs>
  <Slides>9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宋体</vt:lpstr>
      <vt:lpstr>Arial</vt:lpstr>
      <vt:lpstr>Calibri</vt:lpstr>
      <vt:lpstr>Times New Roman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nstitute of genetics and developmental biolog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yaqing</dc:creator>
  <cp:lastModifiedBy>KH</cp:lastModifiedBy>
  <cp:revision>1111</cp:revision>
  <dcterms:created xsi:type="dcterms:W3CDTF">2012-10-08T08:16:02Z</dcterms:created>
  <dcterms:modified xsi:type="dcterms:W3CDTF">2025-08-01T13:33:36Z</dcterms:modified>
</cp:coreProperties>
</file>